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png" ContentType="image/png"/>
  <Override PartName="/ppt/media/image6.jpeg" ContentType="image/jpeg"/>
  <Override PartName="/ppt/media/image27.jpeg" ContentType="image/jpeg"/>
  <Override PartName="/ppt/media/image9.jpeg" ContentType="image/jpeg"/>
  <Override PartName="/ppt/media/image8.jpeg" ContentType="image/jpeg"/>
  <Override PartName="/ppt/media/image12.jpeg" ContentType="image/jpeg"/>
  <Override PartName="/ppt/media/image13.png" ContentType="image/png"/>
  <Override PartName="/ppt/media/image11.png" ContentType="image/png"/>
  <Override PartName="/ppt/media/image7.jpeg" ContentType="image/jpeg"/>
  <Override PartName="/ppt/media/image18.png" ContentType="image/png"/>
  <Override PartName="/ppt/media/image20.png" ContentType="image/png"/>
  <Override PartName="/ppt/media/image5.jpeg" ContentType="image/jpeg"/>
  <Override PartName="/ppt/media/image26.jpeg" ContentType="image/jpe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3.jpeg" ContentType="image/jpeg"/>
  <Override PartName="/ppt/media/image15.png" ContentType="image/png"/>
  <Override PartName="/ppt/media/image2.jpeg" ContentType="image/jpeg"/>
  <Override PartName="/ppt/media/image4.jpeg" ContentType="image/jpeg"/>
  <Override PartName="/ppt/media/image2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F9C83-56A0-4190-81AA-2A4A403957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A86F7-D56A-476C-908B-0AB1ECF868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9655E-AC2E-40AF-90D5-8869A89157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4046B-2B9B-45FB-8085-DC3489E6C3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EAC72-2462-4DFA-B7EB-BE42CF4EEE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1F208-C333-4DA7-8107-AD61776225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07517-2CE3-49EB-8C1A-CC36E9A0B5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CE28A-24B4-4364-BDCC-D0B389DCB3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597CF-C7D4-4666-81D5-26FB052D80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91DD7-2D59-4209-8E0E-2BC4E0AE8F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112A4-351C-40E2-B965-EC44E7826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D79E1-A6D2-4D4C-B599-9EDE2EE8F2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756C57-50DA-424D-8676-6C7646BDF01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1.png"/><Relationship Id="rId5" Type="http://schemas.openxmlformats.org/officeDocument/2006/relationships/image" Target="../media/image2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image" Target="../media/image6.jpeg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image" Target="../media/image9.jpeg"/><Relationship Id="rId1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jpe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jpeg"/><Relationship Id="rId8" Type="http://schemas.openxmlformats.org/officeDocument/2006/relationships/image" Target="../media/image26.jpeg"/><Relationship Id="rId9" Type="http://schemas.openxmlformats.org/officeDocument/2006/relationships/image" Target="../media/image27.jpeg"/><Relationship Id="rId10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0920" y="1413000"/>
            <a:ext cx="93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481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258920" y="692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547640" y="404640"/>
            <a:ext cx="144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Lysotrack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3708360" y="692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3"/>
          <a:stretch/>
        </p:blipFill>
        <p:spPr>
          <a:xfrm>
            <a:off x="6156360" y="692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140360" y="39852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AM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516720" y="398520"/>
            <a:ext cx="144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4"/>
          <a:stretch/>
        </p:blipFill>
        <p:spPr>
          <a:xfrm>
            <a:off x="1258920" y="692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5"/>
          <a:stretch/>
        </p:blipFill>
        <p:spPr>
          <a:xfrm>
            <a:off x="3708360" y="692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79280" y="3284640"/>
            <a:ext cx="93528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523Q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6"/>
          <a:stretch/>
        </p:blipFill>
        <p:spPr>
          <a:xfrm>
            <a:off x="1258920" y="2708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7"/>
          <a:stretch/>
        </p:blipFill>
        <p:spPr>
          <a:xfrm>
            <a:off x="6156360" y="2708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8"/>
          <a:stretch/>
        </p:blipFill>
        <p:spPr>
          <a:xfrm>
            <a:off x="3708360" y="2708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179280" y="5661000"/>
            <a:ext cx="93528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615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9"/>
          <a:stretch/>
        </p:blipFill>
        <p:spPr>
          <a:xfrm>
            <a:off x="1258920" y="4724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10"/>
          <a:stretch/>
        </p:blipFill>
        <p:spPr>
          <a:xfrm>
            <a:off x="6156360" y="4724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11"/>
          <a:stretch/>
        </p:blipFill>
        <p:spPr>
          <a:xfrm>
            <a:off x="3708360" y="4724280"/>
            <a:ext cx="1979640" cy="197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"/>
          <p:cNvSpPr/>
          <p:nvPr/>
        </p:nvSpPr>
        <p:spPr>
          <a:xfrm>
            <a:off x="1332000" y="33336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6360" y="1341360"/>
            <a:ext cx="93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7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-34920" y="3278160"/>
            <a:ext cx="93492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6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-34920" y="5719680"/>
            <a:ext cx="93492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273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971640" y="693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971640" y="2709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971640" y="48070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2989440" y="1298520"/>
            <a:ext cx="93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283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952720" y="3314880"/>
            <a:ext cx="93492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344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952720" y="5699160"/>
            <a:ext cx="93492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34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4"/>
          <a:stretch/>
        </p:blipFill>
        <p:spPr>
          <a:xfrm>
            <a:off x="3851280" y="693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5"/>
          <a:stretch/>
        </p:blipFill>
        <p:spPr>
          <a:xfrm>
            <a:off x="3851280" y="2709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6"/>
          <a:stretch/>
        </p:blipFill>
        <p:spPr>
          <a:xfrm>
            <a:off x="3852720" y="4805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5904000" y="145080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403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832360" y="3322800"/>
            <a:ext cx="93528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424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832360" y="5699160"/>
            <a:ext cx="93528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471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7"/>
          <a:stretch/>
        </p:blipFill>
        <p:spPr>
          <a:xfrm>
            <a:off x="6877080" y="693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8"/>
          <a:stretch/>
        </p:blipFill>
        <p:spPr>
          <a:xfrm>
            <a:off x="6877080" y="270972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9"/>
          <a:stretch/>
        </p:blipFill>
        <p:spPr>
          <a:xfrm>
            <a:off x="6877080" y="479736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4211640" y="33336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380360" y="333360"/>
            <a:ext cx="12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108000" y="141300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482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8000" y="3284640"/>
            <a:ext cx="93492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489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08000" y="5661000"/>
            <a:ext cx="93492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518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971640" y="692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2"/>
          <a:stretch/>
        </p:blipFill>
        <p:spPr>
          <a:xfrm>
            <a:off x="971640" y="2708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3"/>
          <a:stretch/>
        </p:blipFill>
        <p:spPr>
          <a:xfrm>
            <a:off x="971640" y="4724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2952720" y="137808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539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881440" y="3249720"/>
            <a:ext cx="93492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541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881440" y="5626080"/>
            <a:ext cx="93492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562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4"/>
          <a:stretch/>
        </p:blipFill>
        <p:spPr>
          <a:xfrm>
            <a:off x="3816360" y="692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5"/>
          <a:stretch/>
        </p:blipFill>
        <p:spPr>
          <a:xfrm>
            <a:off x="3814920" y="2708280"/>
            <a:ext cx="1979280" cy="197964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6"/>
          <a:stretch/>
        </p:blipFill>
        <p:spPr>
          <a:xfrm>
            <a:off x="3816360" y="4724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5797440" y="1413000"/>
            <a:ext cx="93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76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797440" y="3429000"/>
            <a:ext cx="935280" cy="57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6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7"/>
          <a:stretch/>
        </p:blipFill>
        <p:spPr>
          <a:xfrm>
            <a:off x="6732720" y="692280"/>
            <a:ext cx="1979640" cy="197964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8"/>
          <a:stretch/>
        </p:blipFill>
        <p:spPr>
          <a:xfrm>
            <a:off x="6732720" y="2708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5797440" y="5589720"/>
            <a:ext cx="93528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344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" descr=""/>
          <p:cNvPicPr/>
          <p:nvPr/>
        </p:nvPicPr>
        <p:blipFill>
          <a:blip r:embed="rId9"/>
          <a:stretch/>
        </p:blipFill>
        <p:spPr>
          <a:xfrm>
            <a:off x="6732720" y="4724280"/>
            <a:ext cx="1979640" cy="197964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>
            <a:off x="1332000" y="33336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284720" y="33984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Calnex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7020000" y="33984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Lysotrack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9T19:22:48Z</dcterms:created>
  <dc:creator>Matthew</dc:creator>
  <dc:description/>
  <dc:language>en-US</dc:language>
  <cp:lastModifiedBy>Matthew</cp:lastModifiedBy>
  <dcterms:modified xsi:type="dcterms:W3CDTF">2009-09-25T13:54:22Z</dcterms:modified>
  <cp:revision>8</cp:revision>
  <dc:subject/>
  <dc:title>Slide 1</dc:title>
</cp:coreProperties>
</file>